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90" d="100"/>
          <a:sy n="90" d="100"/>
        </p:scale>
        <p:origin x="576" y="78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462D38-CEEB-6A25-4746-878634BA87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34026A-595E-1BF1-0471-ED618C44C5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ACB462-E5C5-D0A7-3020-766894849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832AEA-EC9B-005B-901D-B86FE8207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9146AC-EC17-C283-5F64-8A6B16636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5576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DC8A5D-C0B7-3D37-1986-1F869EEA88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53E30-39A7-E495-D553-214A2F4C42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921A77-4350-5958-539B-68A04128C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261562-5DBB-42F2-ECC6-620D26EE8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AA049D-FD6E-264E-9C99-39868EBBB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238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8C7628-3637-9497-C124-D61093985A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F35623-9FB4-C451-04C1-08CDF3906E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6685D-12A6-0E38-22C2-84676EDDC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0621CF-F95A-C756-737C-73949BEF5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E76AE0-0372-6B85-81D8-FF1B2256C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8672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5D0BB0-917B-5EAC-E0CF-6AE9E970BD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1FBAE3-68AE-6242-BEB7-80C04F4D3A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A4008C-EB7A-1FA7-958A-8AD63E944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D0725-2F87-DB06-7222-3A955B173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FF371-97B9-10C5-9E7C-BC04EA3E2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4671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A00968-B026-94DD-FDFE-56E0BAAAF6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CC5D47-1F1E-4C82-2EEE-4761C4D43B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6B251E-005F-2F9D-133B-D4E2CD505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A09C85-DAC6-80EA-1E1E-F7387B6F9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C90BFF-A07C-356D-EFC5-1C607E74C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132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45BBF-FA17-EE4B-53F7-822B2090C9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461095-2CB3-B7BC-C97A-18AD8B0775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F25551-5EAA-1643-461F-8162F64AE7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89C582-ABF8-45AF-8DE6-4F5A1A147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3BA909-7BA2-F429-3B34-0D0B8CB45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12DBF9-471D-1715-D084-CAD6E01EB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5758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7D9C0-9CE5-BFD8-91C9-29155E686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029D4B-1AC6-FEDB-DC24-B5526F0507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6520B6-6B52-99B7-7D9A-042094D78A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3B883E-20BB-2476-A062-935E9A7BA6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E2DA8E3-E2BB-C83A-6C11-C6207ED0C6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C1B6AF-5AF1-9C90-8704-103ED1810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372901-DDB2-CF53-DE0A-AC2BA599F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D7FE95-F170-4E9E-99FE-DB23CC3BC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0112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29524-B39E-379D-7B37-D2B047F23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74472F-A256-9FEF-A6A0-4F83B5053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7B5CDC-A506-1DC9-54B7-5B80771C8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5CCE30-7FE7-B395-1BD1-AD42F7B4D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005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EFA988-5F17-3427-9CC5-902A1C90F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5871A3-75C1-C448-DEEA-F53E11A89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6B0E20-D4C8-A635-8FD4-0AAB38E99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0806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550037-CC6E-6B4B-F3E0-80A267CEC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C68E4E-DD52-33EF-7E83-BAABA7AA8F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76FE8B-3354-378C-39E7-1E2388F0DA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93080E-0609-90A5-6B81-E182E7D20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DE7E33-D409-6269-781A-B9A6DAA85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86717E-7C87-8D77-106B-5E97B719A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7164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EC7E8A-FF2F-6AD7-D0D4-0F130331A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B3DFFF-5777-B282-7987-007E8A7A17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735C21-E15D-9414-4930-D3817664D5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3D3AB3-DAD0-0CF6-FCC6-244705003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118AC7-E896-D0A0-2ECB-B3A1760C2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BA1000-9388-7761-F173-FA36EEB117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171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20AAEE-290C-4A21-03CA-9DD19D746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AE8EF0-EECE-E7B5-7D81-802C4C6B7B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B31F1-B391-398A-7B6A-882E2052D6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E35F0-D295-4E90-A680-3B506F8587B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40F85A-EB7F-503E-D529-39DCC18C09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05864E-ADA6-56AC-5755-840E238380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26532A-0B98-4B0D-A179-F087613EFB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650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microsoft.com/office/2007/relationships/hdphoto" Target="../media/hdphoto2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05BDEBB-5B32-20FA-83C7-4EC54A81E14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19062" t="35071" r="38125" b="3430"/>
          <a:stretch/>
        </p:blipFill>
        <p:spPr>
          <a:xfrm>
            <a:off x="2021519" y="1233349"/>
            <a:ext cx="5219700" cy="36099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96BC838-5659-F27F-65FA-425CB4E82254}"/>
              </a:ext>
            </a:extLst>
          </p:cNvPr>
          <p:cNvSpPr txBox="1"/>
          <p:nvPr/>
        </p:nvSpPr>
        <p:spPr>
          <a:xfrm>
            <a:off x="8269919" y="1147254"/>
            <a:ext cx="2883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mmunoblots from Figure 2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848CC85-EC59-CE9A-D5C6-D7C9E2C51D87}"/>
              </a:ext>
            </a:extLst>
          </p:cNvPr>
          <p:cNvSpPr txBox="1"/>
          <p:nvPr/>
        </p:nvSpPr>
        <p:spPr>
          <a:xfrm>
            <a:off x="1462720" y="299465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535CFB18-0274-A85B-6456-30C2DC3B4718}"/>
              </a:ext>
            </a:extLst>
          </p:cNvPr>
          <p:cNvCxnSpPr>
            <a:cxnSpLocks/>
            <a:endCxn id="2" idx="3"/>
          </p:cNvCxnSpPr>
          <p:nvPr/>
        </p:nvCxnSpPr>
        <p:spPr>
          <a:xfrm flipH="1">
            <a:off x="2331869" y="3179324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41947B81-3E40-01ED-22F8-D94F460D924D}"/>
              </a:ext>
            </a:extLst>
          </p:cNvPr>
          <p:cNvCxnSpPr>
            <a:cxnSpLocks/>
          </p:cNvCxnSpPr>
          <p:nvPr/>
        </p:nvCxnSpPr>
        <p:spPr>
          <a:xfrm flipH="1">
            <a:off x="2331869" y="3363990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FC4AD04D-54E9-21B5-FAB0-495B16E795A6}"/>
              </a:ext>
            </a:extLst>
          </p:cNvPr>
          <p:cNvSpPr txBox="1"/>
          <p:nvPr/>
        </p:nvSpPr>
        <p:spPr>
          <a:xfrm>
            <a:off x="1063218" y="3191066"/>
            <a:ext cx="1322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diponectin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D77F733-966F-3538-0495-346DFDA1CDD1}"/>
              </a:ext>
            </a:extLst>
          </p:cNvPr>
          <p:cNvCxnSpPr>
            <a:cxnSpLocks/>
          </p:cNvCxnSpPr>
          <p:nvPr/>
        </p:nvCxnSpPr>
        <p:spPr>
          <a:xfrm flipH="1">
            <a:off x="2377734" y="2736922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E12EBF6B-CE31-D3CF-4B3D-7B4EF2102FD8}"/>
              </a:ext>
            </a:extLst>
          </p:cNvPr>
          <p:cNvSpPr txBox="1"/>
          <p:nvPr/>
        </p:nvSpPr>
        <p:spPr>
          <a:xfrm>
            <a:off x="1028046" y="2527122"/>
            <a:ext cx="1428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PAR-gamma</a:t>
            </a:r>
          </a:p>
        </p:txBody>
      </p:sp>
    </p:spTree>
    <p:extLst>
      <p:ext uri="{BB962C8B-B14F-4D97-AF65-F5344CB8AC3E}">
        <p14:creationId xmlns:p14="http://schemas.microsoft.com/office/powerpoint/2010/main" val="16012317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024D6A5-9951-2880-0739-4BBA8194155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876" t="4781" r="21954" b="33072"/>
          <a:stretch/>
        </p:blipFill>
        <p:spPr>
          <a:xfrm>
            <a:off x="1364203" y="2847141"/>
            <a:ext cx="2780494" cy="185366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8B2DC8F-4AE3-9F09-9758-3510D005228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007" t="5941" r="8823" b="31912"/>
          <a:stretch/>
        </p:blipFill>
        <p:spPr>
          <a:xfrm>
            <a:off x="1364202" y="4853649"/>
            <a:ext cx="2780494" cy="185366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EDA39F5-1C08-50D8-66EC-56DA1538618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18736" t="8116" r="6773" b="21362"/>
          <a:stretch/>
        </p:blipFill>
        <p:spPr>
          <a:xfrm>
            <a:off x="1364202" y="902932"/>
            <a:ext cx="2780494" cy="184026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0852E5A-FF2C-FA48-873C-069BD81AE44E}"/>
              </a:ext>
            </a:extLst>
          </p:cNvPr>
          <p:cNvSpPr txBox="1"/>
          <p:nvPr/>
        </p:nvSpPr>
        <p:spPr>
          <a:xfrm>
            <a:off x="273112" y="5657959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55BA6D8-F846-EC34-8242-52A168F83D9A}"/>
              </a:ext>
            </a:extLst>
          </p:cNvPr>
          <p:cNvSpPr txBox="1"/>
          <p:nvPr/>
        </p:nvSpPr>
        <p:spPr>
          <a:xfrm>
            <a:off x="201238" y="3386755"/>
            <a:ext cx="1040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mentin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E5025CB9-F769-35B1-7B13-9554E3EDDCED}"/>
              </a:ext>
            </a:extLst>
          </p:cNvPr>
          <p:cNvCxnSpPr>
            <a:cxnSpLocks/>
            <a:endCxn id="2" idx="3"/>
          </p:cNvCxnSpPr>
          <p:nvPr/>
        </p:nvCxnSpPr>
        <p:spPr>
          <a:xfrm flipH="1">
            <a:off x="1142261" y="5842625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83381D9-5621-ACA2-24DB-E5375D01C212}"/>
              </a:ext>
            </a:extLst>
          </p:cNvPr>
          <p:cNvCxnSpPr>
            <a:cxnSpLocks/>
          </p:cNvCxnSpPr>
          <p:nvPr/>
        </p:nvCxnSpPr>
        <p:spPr>
          <a:xfrm flipH="1">
            <a:off x="1241395" y="3571421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77196723-A72E-E22C-7F57-8DE837582B95}"/>
              </a:ext>
            </a:extLst>
          </p:cNvPr>
          <p:cNvSpPr txBox="1"/>
          <p:nvPr/>
        </p:nvSpPr>
        <p:spPr>
          <a:xfrm>
            <a:off x="67428" y="1084276"/>
            <a:ext cx="12153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-Cadherin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C4DACFA2-26D5-CFE5-4F3E-BC1C8E3939CA}"/>
              </a:ext>
            </a:extLst>
          </p:cNvPr>
          <p:cNvCxnSpPr>
            <a:cxnSpLocks/>
          </p:cNvCxnSpPr>
          <p:nvPr/>
        </p:nvCxnSpPr>
        <p:spPr>
          <a:xfrm flipH="1">
            <a:off x="1282825" y="1273584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80B9D23-9A75-7C62-9CC8-B37D22EAF259}"/>
              </a:ext>
            </a:extLst>
          </p:cNvPr>
          <p:cNvSpPr txBox="1"/>
          <p:nvPr/>
        </p:nvSpPr>
        <p:spPr>
          <a:xfrm rot="19282126">
            <a:off x="1996390" y="519258"/>
            <a:ext cx="765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KOV-3 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CD606C6-D607-F2DB-E67A-4739A6FDAA3A}"/>
              </a:ext>
            </a:extLst>
          </p:cNvPr>
          <p:cNvSpPr txBox="1"/>
          <p:nvPr/>
        </p:nvSpPr>
        <p:spPr>
          <a:xfrm rot="19282126">
            <a:off x="2330575" y="521184"/>
            <a:ext cx="758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KOV-3 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2D8A02-77A5-9437-3CC3-E7C6ADA7E54B}"/>
              </a:ext>
            </a:extLst>
          </p:cNvPr>
          <p:cNvSpPr txBox="1"/>
          <p:nvPr/>
        </p:nvSpPr>
        <p:spPr>
          <a:xfrm rot="19282126">
            <a:off x="2645160" y="481745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OVCAR-3 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7540269-1588-FE82-3C0B-47B85489689B}"/>
              </a:ext>
            </a:extLst>
          </p:cNvPr>
          <p:cNvSpPr txBox="1"/>
          <p:nvPr/>
        </p:nvSpPr>
        <p:spPr>
          <a:xfrm rot="19282126">
            <a:off x="3022705" y="474347"/>
            <a:ext cx="869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OVCAR-3 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D46BB72-FE51-AB19-9BFB-FB14F615F9B2}"/>
              </a:ext>
            </a:extLst>
          </p:cNvPr>
          <p:cNvSpPr txBox="1"/>
          <p:nvPr/>
        </p:nvSpPr>
        <p:spPr>
          <a:xfrm rot="19282126">
            <a:off x="3401654" y="51343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2780 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A54EA62-DEEB-7589-ADBC-7E31844C577E}"/>
              </a:ext>
            </a:extLst>
          </p:cNvPr>
          <p:cNvSpPr txBox="1"/>
          <p:nvPr/>
        </p:nvSpPr>
        <p:spPr>
          <a:xfrm rot="19282126">
            <a:off x="3779203" y="506036"/>
            <a:ext cx="707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2780 B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679DF032-7E3B-4723-5119-33FB5192513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7386" t="3925" r="22602" b="47663"/>
          <a:stretch/>
        </p:blipFill>
        <p:spPr>
          <a:xfrm>
            <a:off x="5702358" y="902932"/>
            <a:ext cx="2739117" cy="185366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9B3330D-8A3F-EF6C-19F3-8A05BD659131}"/>
              </a:ext>
            </a:extLst>
          </p:cNvPr>
          <p:cNvSpPr txBox="1"/>
          <p:nvPr/>
        </p:nvSpPr>
        <p:spPr>
          <a:xfrm rot="19282126">
            <a:off x="6294579" y="484205"/>
            <a:ext cx="765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KOV-3 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F653FB3-8433-E9AC-A84F-68010A49E4E3}"/>
              </a:ext>
            </a:extLst>
          </p:cNvPr>
          <p:cNvSpPr txBox="1"/>
          <p:nvPr/>
        </p:nvSpPr>
        <p:spPr>
          <a:xfrm rot="19282126">
            <a:off x="6628764" y="486131"/>
            <a:ext cx="758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KOV-3 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D5D4BD4-4A73-6DD0-C59D-94172AD0FFB5}"/>
              </a:ext>
            </a:extLst>
          </p:cNvPr>
          <p:cNvSpPr txBox="1"/>
          <p:nvPr/>
        </p:nvSpPr>
        <p:spPr>
          <a:xfrm rot="19282126">
            <a:off x="6943349" y="446692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OVCAR-3 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096DD10-190C-527C-847F-D55A05FD1D41}"/>
              </a:ext>
            </a:extLst>
          </p:cNvPr>
          <p:cNvSpPr txBox="1"/>
          <p:nvPr/>
        </p:nvSpPr>
        <p:spPr>
          <a:xfrm rot="19282126">
            <a:off x="7320894" y="439294"/>
            <a:ext cx="869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OVCAR-3 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74335C3-C857-4F66-B533-3A38CE84382A}"/>
              </a:ext>
            </a:extLst>
          </p:cNvPr>
          <p:cNvSpPr txBox="1"/>
          <p:nvPr/>
        </p:nvSpPr>
        <p:spPr>
          <a:xfrm rot="19282126">
            <a:off x="7699843" y="478384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2780 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CC18C87-B523-EA86-C731-E2D8AF068BA6}"/>
              </a:ext>
            </a:extLst>
          </p:cNvPr>
          <p:cNvSpPr txBox="1"/>
          <p:nvPr/>
        </p:nvSpPr>
        <p:spPr>
          <a:xfrm rot="19282126">
            <a:off x="8077392" y="470983"/>
            <a:ext cx="707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2780 B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15917043-5A8C-97CE-8953-179CE3C1C9D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822" t="6215" r="7976" b="29701"/>
          <a:stretch/>
        </p:blipFill>
        <p:spPr>
          <a:xfrm>
            <a:off x="5702358" y="2938510"/>
            <a:ext cx="2780494" cy="1853662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BA00C7C9-718E-B493-CFF2-DEB6D46F5745}"/>
              </a:ext>
            </a:extLst>
          </p:cNvPr>
          <p:cNvSpPr txBox="1"/>
          <p:nvPr/>
        </p:nvSpPr>
        <p:spPr>
          <a:xfrm>
            <a:off x="4315828" y="1088918"/>
            <a:ext cx="1252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-Cadherin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D6C341B1-75CA-BF23-0F5E-B26ADD1D29B1}"/>
              </a:ext>
            </a:extLst>
          </p:cNvPr>
          <p:cNvCxnSpPr>
            <a:cxnSpLocks/>
          </p:cNvCxnSpPr>
          <p:nvPr/>
        </p:nvCxnSpPr>
        <p:spPr>
          <a:xfrm flipH="1">
            <a:off x="5531225" y="1278226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7C48D59E-3ECB-87B6-2C89-7970FB4A48D5}"/>
              </a:ext>
            </a:extLst>
          </p:cNvPr>
          <p:cNvSpPr txBox="1"/>
          <p:nvPr/>
        </p:nvSpPr>
        <p:spPr>
          <a:xfrm>
            <a:off x="4662076" y="366196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F0EF78D5-2DE9-3FEB-048D-C549D7FC1719}"/>
              </a:ext>
            </a:extLst>
          </p:cNvPr>
          <p:cNvCxnSpPr>
            <a:cxnSpLocks/>
            <a:endCxn id="33" idx="3"/>
          </p:cNvCxnSpPr>
          <p:nvPr/>
        </p:nvCxnSpPr>
        <p:spPr>
          <a:xfrm flipH="1">
            <a:off x="5531225" y="3846629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2651392-4DD9-BA1A-9367-0366A92ADB13}"/>
              </a:ext>
            </a:extLst>
          </p:cNvPr>
          <p:cNvSpPr txBox="1"/>
          <p:nvPr/>
        </p:nvSpPr>
        <p:spPr>
          <a:xfrm>
            <a:off x="5983550" y="5477522"/>
            <a:ext cx="2750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mmunoblots from Figure 4</a:t>
            </a:r>
          </a:p>
        </p:txBody>
      </p:sp>
    </p:spTree>
    <p:extLst>
      <p:ext uri="{BB962C8B-B14F-4D97-AF65-F5344CB8AC3E}">
        <p14:creationId xmlns:p14="http://schemas.microsoft.com/office/powerpoint/2010/main" val="3663917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790A43F-829A-7B40-A868-3F50C21657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574" t="20655" r="14825" b="32735"/>
          <a:stretch/>
        </p:blipFill>
        <p:spPr>
          <a:xfrm>
            <a:off x="1735097" y="5152790"/>
            <a:ext cx="3095627" cy="149213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A68F715-38C8-E90C-1ADB-822C231FB98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989" t="27186" r="13409" b="47190"/>
          <a:stretch/>
        </p:blipFill>
        <p:spPr>
          <a:xfrm>
            <a:off x="1700567" y="1361149"/>
            <a:ext cx="3095625" cy="82030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5A92F51-0B92-4B1A-2977-DE8DEA344C8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162" t="14985" r="9644" b="35855"/>
          <a:stretch/>
        </p:blipFill>
        <p:spPr>
          <a:xfrm>
            <a:off x="1735099" y="2211722"/>
            <a:ext cx="3095625" cy="139632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D0C0CED-7482-C7BB-FFBA-9393A4AF16A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282" t="18454" r="15632" b="31921"/>
          <a:stretch/>
        </p:blipFill>
        <p:spPr>
          <a:xfrm>
            <a:off x="1735098" y="3621113"/>
            <a:ext cx="3095626" cy="144959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89E2AFF-FCF2-4B0D-28C5-9CA61E12AC1A}"/>
              </a:ext>
            </a:extLst>
          </p:cNvPr>
          <p:cNvSpPr txBox="1"/>
          <p:nvPr/>
        </p:nvSpPr>
        <p:spPr>
          <a:xfrm rot="16200000">
            <a:off x="1886737" y="614038"/>
            <a:ext cx="1000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OVCAR-3</a:t>
            </a:r>
          </a:p>
          <a:p>
            <a:r>
              <a:rPr lang="en-GB" sz="1200" dirty="0"/>
              <a:t>Monocultu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37A7D56-B4AD-05B4-6BEB-8A3109603231}"/>
              </a:ext>
            </a:extLst>
          </p:cNvPr>
          <p:cNvSpPr txBox="1"/>
          <p:nvPr/>
        </p:nvSpPr>
        <p:spPr>
          <a:xfrm rot="16200000">
            <a:off x="2314825" y="743465"/>
            <a:ext cx="925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 Adipocyt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CC8B292-8BA9-F9B5-7D0B-E094A8E150B9}"/>
              </a:ext>
            </a:extLst>
          </p:cNvPr>
          <p:cNvSpPr txBox="1"/>
          <p:nvPr/>
        </p:nvSpPr>
        <p:spPr>
          <a:xfrm rot="16200000">
            <a:off x="2803411" y="882988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 ADS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32C19C7-BE8D-6108-2DA1-89AB320B572A}"/>
              </a:ext>
            </a:extLst>
          </p:cNvPr>
          <p:cNvSpPr txBox="1"/>
          <p:nvPr/>
        </p:nvSpPr>
        <p:spPr>
          <a:xfrm>
            <a:off x="345464" y="1512973"/>
            <a:ext cx="1252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-Cadher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D398987-16D3-82D4-3CCB-E31FC3958350}"/>
              </a:ext>
            </a:extLst>
          </p:cNvPr>
          <p:cNvSpPr txBox="1"/>
          <p:nvPr/>
        </p:nvSpPr>
        <p:spPr>
          <a:xfrm>
            <a:off x="398819" y="2492976"/>
            <a:ext cx="12153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-Cadher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A1C5331-104B-8F97-EAFD-231EA2301F86}"/>
              </a:ext>
            </a:extLst>
          </p:cNvPr>
          <p:cNvSpPr txBox="1"/>
          <p:nvPr/>
        </p:nvSpPr>
        <p:spPr>
          <a:xfrm>
            <a:off x="398819" y="3843228"/>
            <a:ext cx="1040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ment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9E009F5-EB4E-BEED-E369-24B25318E025}"/>
              </a:ext>
            </a:extLst>
          </p:cNvPr>
          <p:cNvSpPr txBox="1"/>
          <p:nvPr/>
        </p:nvSpPr>
        <p:spPr>
          <a:xfrm>
            <a:off x="484322" y="543390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B58D741-E196-83A3-FF89-8B8B002CC336}"/>
              </a:ext>
            </a:extLst>
          </p:cNvPr>
          <p:cNvSpPr txBox="1"/>
          <p:nvPr/>
        </p:nvSpPr>
        <p:spPr>
          <a:xfrm>
            <a:off x="6782428" y="4345910"/>
            <a:ext cx="2750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mmunoblots from Figure 5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96A836DE-5ABB-160D-B2AC-06C1C0FA038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0665" t="17520" r="23096" b="41711"/>
          <a:stretch/>
        </p:blipFill>
        <p:spPr>
          <a:xfrm>
            <a:off x="6782428" y="702859"/>
            <a:ext cx="3305172" cy="1675206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E16BB38F-6564-4609-08C0-C040FF9D392D}"/>
              </a:ext>
            </a:extLst>
          </p:cNvPr>
          <p:cNvSpPr txBox="1"/>
          <p:nvPr/>
        </p:nvSpPr>
        <p:spPr>
          <a:xfrm rot="18785577">
            <a:off x="7933379" y="46222"/>
            <a:ext cx="1000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KOV-3</a:t>
            </a:r>
          </a:p>
          <a:p>
            <a:r>
              <a:rPr lang="en-GB" sz="1200" dirty="0"/>
              <a:t>Monocultur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D2A9066-C755-7C16-A5FA-628DD62CA5F8}"/>
              </a:ext>
            </a:extLst>
          </p:cNvPr>
          <p:cNvSpPr txBox="1"/>
          <p:nvPr/>
        </p:nvSpPr>
        <p:spPr>
          <a:xfrm rot="18785577">
            <a:off x="8387912" y="228722"/>
            <a:ext cx="925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 Adipocyt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7D8F7D3-C02F-A51A-7DA7-53A516CB19D5}"/>
              </a:ext>
            </a:extLst>
          </p:cNvPr>
          <p:cNvSpPr txBox="1"/>
          <p:nvPr/>
        </p:nvSpPr>
        <p:spPr>
          <a:xfrm rot="18785577">
            <a:off x="8785003" y="335502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 ADS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DDA8A5D-E9BC-5CD9-F942-37C8E0792387}"/>
              </a:ext>
            </a:extLst>
          </p:cNvPr>
          <p:cNvSpPr txBox="1"/>
          <p:nvPr/>
        </p:nvSpPr>
        <p:spPr>
          <a:xfrm>
            <a:off x="5672938" y="706779"/>
            <a:ext cx="1040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mentin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AF9A845-6769-6205-4877-3CF17D4EE058}"/>
              </a:ext>
            </a:extLst>
          </p:cNvPr>
          <p:cNvCxnSpPr>
            <a:cxnSpLocks/>
          </p:cNvCxnSpPr>
          <p:nvPr/>
        </p:nvCxnSpPr>
        <p:spPr>
          <a:xfrm flipH="1">
            <a:off x="6713095" y="891445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2C7BDEE5-4413-F407-C599-FB4B5BD7AD86}"/>
              </a:ext>
            </a:extLst>
          </p:cNvPr>
          <p:cNvSpPr txBox="1"/>
          <p:nvPr/>
        </p:nvSpPr>
        <p:spPr>
          <a:xfrm>
            <a:off x="5707604" y="1080757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5898405-EC77-4191-DF9C-82FFEA64DBB2}"/>
              </a:ext>
            </a:extLst>
          </p:cNvPr>
          <p:cNvCxnSpPr>
            <a:cxnSpLocks/>
          </p:cNvCxnSpPr>
          <p:nvPr/>
        </p:nvCxnSpPr>
        <p:spPr>
          <a:xfrm flipH="1">
            <a:off x="6747761" y="1265423"/>
            <a:ext cx="66878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8E8F3CA9-EAD5-7A31-957A-7C48943ABAAA}"/>
              </a:ext>
            </a:extLst>
          </p:cNvPr>
          <p:cNvSpPr txBox="1"/>
          <p:nvPr/>
        </p:nvSpPr>
        <p:spPr>
          <a:xfrm rot="16200000">
            <a:off x="3016512" y="762409"/>
            <a:ext cx="925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 Adipocyt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EA7444B-9260-379E-4A6B-3F7EE8F7343D}"/>
              </a:ext>
            </a:extLst>
          </p:cNvPr>
          <p:cNvSpPr txBox="1"/>
          <p:nvPr/>
        </p:nvSpPr>
        <p:spPr>
          <a:xfrm rot="16200000">
            <a:off x="3474013" y="903753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 ADSC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9D8F465-ABF0-9631-5C23-597A7BC8C895}"/>
              </a:ext>
            </a:extLst>
          </p:cNvPr>
          <p:cNvSpPr txBox="1"/>
          <p:nvPr/>
        </p:nvSpPr>
        <p:spPr>
          <a:xfrm>
            <a:off x="2582925" y="68155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D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8AB0135-5AEB-B2EB-AE81-34FA08A86AD6}"/>
              </a:ext>
            </a:extLst>
          </p:cNvPr>
          <p:cNvSpPr txBox="1"/>
          <p:nvPr/>
        </p:nvSpPr>
        <p:spPr>
          <a:xfrm>
            <a:off x="3324004" y="67526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2D</a:t>
            </a:r>
          </a:p>
        </p:txBody>
      </p:sp>
    </p:spTree>
    <p:extLst>
      <p:ext uri="{BB962C8B-B14F-4D97-AF65-F5344CB8AC3E}">
        <p14:creationId xmlns:p14="http://schemas.microsoft.com/office/powerpoint/2010/main" val="428970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7423C24-695A-E481-3624-157671102F24}"/>
              </a:ext>
            </a:extLst>
          </p:cNvPr>
          <p:cNvSpPr txBox="1"/>
          <p:nvPr/>
        </p:nvSpPr>
        <p:spPr>
          <a:xfrm>
            <a:off x="1185524" y="111877"/>
            <a:ext cx="1709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-cadherin blot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A9321FF-2C25-3D22-E082-BB0300426E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83" t="-273" r="14016"/>
          <a:stretch/>
        </p:blipFill>
        <p:spPr>
          <a:xfrm>
            <a:off x="5099590" y="703354"/>
            <a:ext cx="3215115" cy="266184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1DC077D-1FA9-4AFC-0415-2184C6C546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2045" y="703354"/>
            <a:ext cx="3647335" cy="2570768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57C61C77-DE89-70E8-FB25-69F9BF1195B5}"/>
              </a:ext>
            </a:extLst>
          </p:cNvPr>
          <p:cNvCxnSpPr>
            <a:cxnSpLocks/>
          </p:cNvCxnSpPr>
          <p:nvPr/>
        </p:nvCxnSpPr>
        <p:spPr>
          <a:xfrm>
            <a:off x="4720856" y="372140"/>
            <a:ext cx="0" cy="604380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40D11CAE-22CB-DF1E-5AD3-A07EB675A934}"/>
              </a:ext>
            </a:extLst>
          </p:cNvPr>
          <p:cNvSpPr txBox="1"/>
          <p:nvPr/>
        </p:nvSpPr>
        <p:spPr>
          <a:xfrm>
            <a:off x="5696761" y="217490"/>
            <a:ext cx="1744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-cadherin blo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81B9CE-189B-D09C-54F1-80CAEA79413D}"/>
              </a:ext>
            </a:extLst>
          </p:cNvPr>
          <p:cNvSpPr txBox="1"/>
          <p:nvPr/>
        </p:nvSpPr>
        <p:spPr>
          <a:xfrm>
            <a:off x="9060193" y="232961"/>
            <a:ext cx="1513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mentin b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B9CE02C-2594-6C15-0A98-C7D91EEA7F21}"/>
              </a:ext>
            </a:extLst>
          </p:cNvPr>
          <p:cNvSpPr txBox="1"/>
          <p:nvPr/>
        </p:nvSpPr>
        <p:spPr>
          <a:xfrm>
            <a:off x="5058642" y="3577474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nculin blot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6C0A0C7-CE31-6D72-6D5A-6B1F8A134F0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705" y="3577474"/>
            <a:ext cx="3885835" cy="272725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3721B99-5744-6459-5F9E-FA0967614B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9939" y="476638"/>
            <a:ext cx="3839849" cy="295693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6492630-C755-8596-2C5A-CDDD75428421}"/>
              </a:ext>
            </a:extLst>
          </p:cNvPr>
          <p:cNvSpPr txBox="1"/>
          <p:nvPr/>
        </p:nvSpPr>
        <p:spPr>
          <a:xfrm>
            <a:off x="200705" y="34122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nculin blo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A4E71D8-A91F-E1E3-86C7-26CABB6C44F2}"/>
              </a:ext>
            </a:extLst>
          </p:cNvPr>
          <p:cNvSpPr txBox="1"/>
          <p:nvPr/>
        </p:nvSpPr>
        <p:spPr>
          <a:xfrm>
            <a:off x="6241312" y="4933507"/>
            <a:ext cx="2715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mmunoblots from figure 7</a:t>
            </a:r>
          </a:p>
        </p:txBody>
      </p:sp>
    </p:spTree>
    <p:extLst>
      <p:ext uri="{BB962C8B-B14F-4D97-AF65-F5344CB8AC3E}">
        <p14:creationId xmlns:p14="http://schemas.microsoft.com/office/powerpoint/2010/main" val="1332413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82</Words>
  <Application>Microsoft Office PowerPoint</Application>
  <PresentationFormat>Widescreen</PresentationFormat>
  <Paragraphs>4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e</dc:creator>
  <cp:lastModifiedBy>Mike Williams</cp:lastModifiedBy>
  <cp:revision>4</cp:revision>
  <dcterms:created xsi:type="dcterms:W3CDTF">2023-09-28T16:36:27Z</dcterms:created>
  <dcterms:modified xsi:type="dcterms:W3CDTF">2024-07-17T07:30:38Z</dcterms:modified>
</cp:coreProperties>
</file>